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58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971708"/>
            <a:ext cx="116681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Within environments correlation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) between observed and predicted values for four models under the cross-validation scheme CV00 which mimics the prediction scenario of new genotypes in novel environments (predicting untested genotypes in unobserved environments);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 depicts the number of genotypes tested at each environment. Environments with correlations below zero are connected with a blue line. 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Diagram, schematic, scatter chart&#10;&#10;Description automatically generated">
            <a:extLst>
              <a:ext uri="{FF2B5EF4-FFF2-40B4-BE49-F238E27FC236}">
                <a16:creationId xmlns:a16="http://schemas.microsoft.com/office/drawing/2014/main" id="{BE9719D5-CA51-D755-8164-8C8514A291E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1"/>
            <a:ext cx="5899127" cy="589912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5</cp:revision>
  <dcterms:created xsi:type="dcterms:W3CDTF">2022-08-30T03:12:47Z</dcterms:created>
  <dcterms:modified xsi:type="dcterms:W3CDTF">2022-08-30T03:24:50Z</dcterms:modified>
</cp:coreProperties>
</file>